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C6BFC-A4BF-4527-80D3-D69544BD2E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F2571-F853-443B-AC16-81B6645105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97E70-9113-41B8-B6EF-7B775D4793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B4EED-586D-4E35-B3F3-42CA36E3A7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D42FD-5E01-49BF-8408-8A4D2FC4B3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4BC58-CCDE-4E51-8664-9A1E78BD0F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A2F6B-8C66-407E-820E-EC080282DE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F763F-F117-471D-84B7-A40F4D5AEF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9269B-9D9C-4842-BE64-13C06A7361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DE294-F2C8-475D-B7DA-C653B78566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66420-7F42-41CA-ABC5-A42088F550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2D215-68AA-4E02-B6E6-2201184D5A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10FC617-2B2F-4B74-AFCF-1AD0FBCE770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73160" y="1866960"/>
          <a:ext cx="4876920" cy="2800440"/>
        </p:xfrm>
        <a:graphic>
          <a:graphicData uri="http://schemas.openxmlformats.org/drawingml/2006/table">
            <a:tbl>
              <a:tblPr/>
              <a:tblGrid>
                <a:gridCol w="774720"/>
                <a:gridCol w="673200"/>
                <a:gridCol w="673200"/>
                <a:gridCol w="672840"/>
                <a:gridCol w="736920"/>
                <a:gridCol w="672840"/>
                <a:gridCol w="673200"/>
              </a:tblGrid>
              <a:tr h="295200">
                <a:tc gridSpan="7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LB size and frequenc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6196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brid cell l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an siz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. Devi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nimum siz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ximum siz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an (% of total cell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. Devi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1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6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7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5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4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8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364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1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1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6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3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8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3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3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4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2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77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364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3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2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9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6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7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3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9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8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7</a:t>
                      </a:r>
                      <a:r>
                        <a:rPr b="1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2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6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7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1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1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3T13:40:15Z</dcterms:created>
  <dc:creator>Emily Cronin-Furman</dc:creator>
  <dc:description/>
  <dc:language>en-US</dc:language>
  <cp:lastModifiedBy>Pat Trimmer</cp:lastModifiedBy>
  <dcterms:modified xsi:type="dcterms:W3CDTF">2012-12-11T20:34:07Z</dcterms:modified>
  <cp:revision>5</cp:revision>
  <dc:subject/>
  <dc:title>PowerPoint Presentation</dc:title>
</cp:coreProperties>
</file>